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7108" autoAdjust="0"/>
    <p:restoredTop sz="94660"/>
  </p:normalViewPr>
  <p:slideViewPr>
    <p:cSldViewPr snapToGrid="0" snapToObjects="1">
      <p:cViewPr>
        <p:scale>
          <a:sx n="100" d="100"/>
          <a:sy n="100" d="100"/>
        </p:scale>
        <p:origin x="-972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234264-663B-4C14-9238-87A58890A8FB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8EE391-FAB3-4B27-BFBF-CB640B5892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78647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2777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328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749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071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67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832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1647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0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13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7832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2271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880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矢印: 下 34">
            <a:extLst>
              <a:ext uri="{FF2B5EF4-FFF2-40B4-BE49-F238E27FC236}">
                <a16:creationId xmlns:a16="http://schemas.microsoft.com/office/drawing/2014/main" xmlns="" id="{BB212232-C321-4081-A0F1-A1CA61A7BB3A}"/>
              </a:ext>
            </a:extLst>
          </p:cNvPr>
          <p:cNvSpPr/>
          <p:nvPr/>
        </p:nvSpPr>
        <p:spPr>
          <a:xfrm>
            <a:off x="5285279" y="7216901"/>
            <a:ext cx="270094" cy="175954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矢印: 下 33">
            <a:extLst>
              <a:ext uri="{FF2B5EF4-FFF2-40B4-BE49-F238E27FC236}">
                <a16:creationId xmlns:a16="http://schemas.microsoft.com/office/drawing/2014/main" xmlns="" id="{4782807C-D9B3-48C3-8904-9C0BB9140123}"/>
              </a:ext>
            </a:extLst>
          </p:cNvPr>
          <p:cNvSpPr/>
          <p:nvPr/>
        </p:nvSpPr>
        <p:spPr>
          <a:xfrm>
            <a:off x="3854017" y="6362519"/>
            <a:ext cx="270094" cy="175954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矢印: 下 32">
            <a:extLst>
              <a:ext uri="{FF2B5EF4-FFF2-40B4-BE49-F238E27FC236}">
                <a16:creationId xmlns:a16="http://schemas.microsoft.com/office/drawing/2014/main" xmlns="" id="{7CD49B02-2BE0-4530-BE4E-AE5F815B2EB0}"/>
              </a:ext>
            </a:extLst>
          </p:cNvPr>
          <p:cNvSpPr/>
          <p:nvPr/>
        </p:nvSpPr>
        <p:spPr>
          <a:xfrm>
            <a:off x="2337335" y="7216901"/>
            <a:ext cx="270094" cy="175954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矢印: 下 31">
            <a:extLst>
              <a:ext uri="{FF2B5EF4-FFF2-40B4-BE49-F238E27FC236}">
                <a16:creationId xmlns:a16="http://schemas.microsoft.com/office/drawing/2014/main" xmlns="" id="{B35483A8-F67C-40A9-8EEC-BE6D8346A7C2}"/>
              </a:ext>
            </a:extLst>
          </p:cNvPr>
          <p:cNvSpPr/>
          <p:nvPr/>
        </p:nvSpPr>
        <p:spPr>
          <a:xfrm>
            <a:off x="850407" y="6311735"/>
            <a:ext cx="255940" cy="1810333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B644E3B3-ECD3-4948-9619-A72421C8F383}"/>
              </a:ext>
            </a:extLst>
          </p:cNvPr>
          <p:cNvSpPr txBox="1"/>
          <p:nvPr/>
        </p:nvSpPr>
        <p:spPr>
          <a:xfrm>
            <a:off x="548982" y="790386"/>
            <a:ext cx="422608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17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ients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went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ical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ection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stric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矢印: 下 6">
            <a:extLst>
              <a:ext uri="{FF2B5EF4-FFF2-40B4-BE49-F238E27FC236}">
                <a16:creationId xmlns:a16="http://schemas.microsoft.com/office/drawing/2014/main" xmlns="" id="{AD072EFB-E1E9-4144-A1E2-790831899CFF}"/>
              </a:ext>
            </a:extLst>
          </p:cNvPr>
          <p:cNvSpPr/>
          <p:nvPr/>
        </p:nvSpPr>
        <p:spPr>
          <a:xfrm>
            <a:off x="846205" y="1128327"/>
            <a:ext cx="259597" cy="1020983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1FF13669-3A4C-452D-A62E-B88CB257EB8C}"/>
              </a:ext>
            </a:extLst>
          </p:cNvPr>
          <p:cNvSpPr txBox="1"/>
          <p:nvPr/>
        </p:nvSpPr>
        <p:spPr>
          <a:xfrm>
            <a:off x="1502284" y="1225531"/>
            <a:ext cx="3492136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 patients with residual gastric cancer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 patients with esophagogastric junction cancer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3 patients with gastric tube cance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D7139CF2-BCF6-4CED-9B8F-8E8DCEBE5303}"/>
              </a:ext>
            </a:extLst>
          </p:cNvPr>
          <p:cNvSpPr txBox="1"/>
          <p:nvPr/>
        </p:nvSpPr>
        <p:spPr>
          <a:xfrm>
            <a:off x="548983" y="2208656"/>
            <a:ext cx="468298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9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ients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went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ical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ection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primary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stric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矢印: 下 12">
            <a:extLst>
              <a:ext uri="{FF2B5EF4-FFF2-40B4-BE49-F238E27FC236}">
                <a16:creationId xmlns:a16="http://schemas.microsoft.com/office/drawing/2014/main" xmlns="" id="{58340A9E-28DF-47E3-9F22-3EB43C380BF5}"/>
              </a:ext>
            </a:extLst>
          </p:cNvPr>
          <p:cNvSpPr/>
          <p:nvPr/>
        </p:nvSpPr>
        <p:spPr>
          <a:xfrm>
            <a:off x="846205" y="2552285"/>
            <a:ext cx="259597" cy="117247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822B4CE7-5C6E-42DD-8247-F86962C31DAD}"/>
              </a:ext>
            </a:extLst>
          </p:cNvPr>
          <p:cNvSpPr txBox="1"/>
          <p:nvPr/>
        </p:nvSpPr>
        <p:spPr>
          <a:xfrm>
            <a:off x="1502282" y="2644878"/>
            <a:ext cx="4317273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patients with circumferential gastric cancer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 patients with administration of neoadjuvant chemotherapy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 patients with multiple gastric cancer</a:t>
            </a:r>
          </a:p>
          <a:p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re-operation according to pathological result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354C6E6E-586C-4081-8CD2-DD70C7A07871}"/>
              </a:ext>
            </a:extLst>
          </p:cNvPr>
          <p:cNvSpPr txBox="1"/>
          <p:nvPr/>
        </p:nvSpPr>
        <p:spPr>
          <a:xfrm>
            <a:off x="548982" y="3830259"/>
            <a:ext cx="102538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41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ients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矢印: 下 15">
            <a:extLst>
              <a:ext uri="{FF2B5EF4-FFF2-40B4-BE49-F238E27FC236}">
                <a16:creationId xmlns:a16="http://schemas.microsoft.com/office/drawing/2014/main" xmlns="" id="{EB697A93-537A-4E27-B814-D7EA633F55F1}"/>
              </a:ext>
            </a:extLst>
          </p:cNvPr>
          <p:cNvSpPr/>
          <p:nvPr/>
        </p:nvSpPr>
        <p:spPr>
          <a:xfrm>
            <a:off x="850407" y="4170697"/>
            <a:ext cx="255940" cy="128116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矢印: 上向き折線 16">
            <a:extLst>
              <a:ext uri="{FF2B5EF4-FFF2-40B4-BE49-F238E27FC236}">
                <a16:creationId xmlns:a16="http://schemas.microsoft.com/office/drawing/2014/main" xmlns="" id="{56BF1657-6059-4363-B11D-8DB90D288026}"/>
              </a:ext>
            </a:extLst>
          </p:cNvPr>
          <p:cNvSpPr/>
          <p:nvPr/>
        </p:nvSpPr>
        <p:spPr>
          <a:xfrm rot="10800000" flipH="1">
            <a:off x="1061675" y="4834462"/>
            <a:ext cx="1545753" cy="1588953"/>
          </a:xfrm>
          <a:prstGeom prst="bentUpArrow">
            <a:avLst>
              <a:gd name="adj1" fmla="val 10378"/>
              <a:gd name="adj2" fmla="val 9463"/>
              <a:gd name="adj3" fmla="val 10026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xmlns="" id="{0F9622AE-BD50-44DF-B1C8-1C26DFDCD8F7}"/>
              </a:ext>
            </a:extLst>
          </p:cNvPr>
          <p:cNvSpPr/>
          <p:nvPr/>
        </p:nvSpPr>
        <p:spPr>
          <a:xfrm>
            <a:off x="1502282" y="4266026"/>
            <a:ext cx="3613499" cy="4616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atients were classified into the following 4 groups </a:t>
            </a:r>
          </a:p>
          <a:p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ccording to clinical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athological diagnosis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xmlns="" id="{3B94C3B0-894C-4F28-9137-4C56690B7C38}"/>
              </a:ext>
            </a:extLst>
          </p:cNvPr>
          <p:cNvSpPr/>
          <p:nvPr/>
        </p:nvSpPr>
        <p:spPr>
          <a:xfrm>
            <a:off x="1827787" y="6492868"/>
            <a:ext cx="1289189" cy="4616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-look AGC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2 patient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xmlns="" id="{980B9619-EE9C-45AA-8BC3-426BBC274CA8}"/>
              </a:ext>
            </a:extLst>
          </p:cNvPr>
          <p:cNvSpPr/>
          <p:nvPr/>
        </p:nvSpPr>
        <p:spPr>
          <a:xfrm>
            <a:off x="346202" y="5558634"/>
            <a:ext cx="1301703" cy="4616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-look EGC 410 patient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xmlns="" id="{A4904016-D4F3-4F36-8C1A-B97DF190DDF4}"/>
              </a:ext>
            </a:extLst>
          </p:cNvPr>
          <p:cNvSpPr/>
          <p:nvPr/>
        </p:nvSpPr>
        <p:spPr>
          <a:xfrm>
            <a:off x="3212266" y="5558634"/>
            <a:ext cx="1562796" cy="4616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anced-look EGC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 patient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xmlns="" id="{D6C04AD7-F017-43C1-8C5F-E5DB83550D39}"/>
              </a:ext>
            </a:extLst>
          </p:cNvPr>
          <p:cNvSpPr/>
          <p:nvPr/>
        </p:nvSpPr>
        <p:spPr>
          <a:xfrm>
            <a:off x="4608178" y="6492868"/>
            <a:ext cx="1624295" cy="4616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anced-look AGC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2 patient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矢印: 上向き折線 25">
            <a:extLst>
              <a:ext uri="{FF2B5EF4-FFF2-40B4-BE49-F238E27FC236}">
                <a16:creationId xmlns:a16="http://schemas.microsoft.com/office/drawing/2014/main" xmlns="" id="{F8702D45-A4D3-4D3B-850D-40EA667EFE8C}"/>
              </a:ext>
            </a:extLst>
          </p:cNvPr>
          <p:cNvSpPr/>
          <p:nvPr/>
        </p:nvSpPr>
        <p:spPr>
          <a:xfrm rot="10800000" flipH="1">
            <a:off x="2533015" y="4835441"/>
            <a:ext cx="1556748" cy="616422"/>
          </a:xfrm>
          <a:prstGeom prst="bentUpArrow">
            <a:avLst>
              <a:gd name="adj1" fmla="val 24633"/>
              <a:gd name="adj2" fmla="val 20753"/>
              <a:gd name="adj3" fmla="val 20318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BCB86E3F-0F69-47C6-B9D2-0A3EABD44905}"/>
              </a:ext>
            </a:extLst>
          </p:cNvPr>
          <p:cNvSpPr txBox="1"/>
          <p:nvPr/>
        </p:nvSpPr>
        <p:spPr>
          <a:xfrm>
            <a:off x="244914" y="197914"/>
            <a:ext cx="2311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矢印: 上向き折線 18">
            <a:extLst>
              <a:ext uri="{FF2B5EF4-FFF2-40B4-BE49-F238E27FC236}">
                <a16:creationId xmlns:a16="http://schemas.microsoft.com/office/drawing/2014/main" xmlns="" id="{6CD7DBD4-831A-4706-9FFE-39F1704832C2}"/>
              </a:ext>
            </a:extLst>
          </p:cNvPr>
          <p:cNvSpPr/>
          <p:nvPr/>
        </p:nvSpPr>
        <p:spPr>
          <a:xfrm rot="10800000" flipH="1">
            <a:off x="4020695" y="4835441"/>
            <a:ext cx="1540408" cy="1587974"/>
          </a:xfrm>
          <a:prstGeom prst="bentUpArrow">
            <a:avLst>
              <a:gd name="adj1" fmla="val 10378"/>
              <a:gd name="adj2" fmla="val 9463"/>
              <a:gd name="adj3" fmla="val 1057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7A7C2798-8478-4F9D-8774-A45A3AAECE96}"/>
              </a:ext>
            </a:extLst>
          </p:cNvPr>
          <p:cNvSpPr txBox="1"/>
          <p:nvPr/>
        </p:nvSpPr>
        <p:spPr>
          <a:xfrm>
            <a:off x="253381" y="7364747"/>
            <a:ext cx="6254076" cy="46166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ded for prognostic analyses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9 patients with s</a:t>
            </a:r>
            <a:r>
              <a:rPr kumimoji="0" lang="ja-JP" altLang="ja-JP" sz="1200" dirty="0">
                <a:latin typeface="Times New Roman" panose="02020603050405020304" pitchFamily="18" charset="0"/>
                <a:ea typeface="inherit"/>
                <a:cs typeface="Times New Roman" panose="02020603050405020304" pitchFamily="18" charset="0"/>
              </a:rPr>
              <a:t>ynchronous or metachronous other cancer within 5 years before surgery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xmlns="" id="{3705E7BF-3C77-428C-BA5C-A4161645BEA3}"/>
              </a:ext>
            </a:extLst>
          </p:cNvPr>
          <p:cNvSpPr/>
          <p:nvPr/>
        </p:nvSpPr>
        <p:spPr>
          <a:xfrm>
            <a:off x="1827787" y="9037291"/>
            <a:ext cx="1289189" cy="4616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-look AGC 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 patient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xmlns="" id="{8C8E5E0A-1CF2-4CED-847B-B1470CE8AB27}"/>
              </a:ext>
            </a:extLst>
          </p:cNvPr>
          <p:cNvSpPr/>
          <p:nvPr/>
        </p:nvSpPr>
        <p:spPr>
          <a:xfrm>
            <a:off x="346202" y="8227985"/>
            <a:ext cx="1301703" cy="4616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-look EGC 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85 patient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xmlns="" id="{45B0D452-4029-45FB-9C70-7AAEF7C46BEC}"/>
              </a:ext>
            </a:extLst>
          </p:cNvPr>
          <p:cNvSpPr/>
          <p:nvPr/>
        </p:nvSpPr>
        <p:spPr>
          <a:xfrm>
            <a:off x="3212266" y="8227985"/>
            <a:ext cx="1562796" cy="4616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anced-look EGC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 patient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xmlns="" id="{D3C8D55F-D650-442A-8559-40A4A8796C29}"/>
              </a:ext>
            </a:extLst>
          </p:cNvPr>
          <p:cNvSpPr/>
          <p:nvPr/>
        </p:nvSpPr>
        <p:spPr>
          <a:xfrm>
            <a:off x="4608178" y="9037292"/>
            <a:ext cx="1624295" cy="4616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anced-look AGC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6 patient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600070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85</TotalTime>
  <Words>133</Words>
  <Application>Microsoft Office PowerPoint</Application>
  <PresentationFormat>A4 Paper (210x297 mm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ホワイト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庄田 勝俊</dc:creator>
  <cp:lastModifiedBy>SBUCOL</cp:lastModifiedBy>
  <cp:revision>85</cp:revision>
  <cp:lastPrinted>2020-07-02T14:53:20Z</cp:lastPrinted>
  <dcterms:created xsi:type="dcterms:W3CDTF">2019-03-25T10:47:55Z</dcterms:created>
  <dcterms:modified xsi:type="dcterms:W3CDTF">2020-08-23T23:57:43Z</dcterms:modified>
</cp:coreProperties>
</file>